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32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7C36602C-36D2-485B-8966-F939997DAA65}" type="doc">
      <dgm:prSet loTypeId="urn:microsoft.com/office/officeart/2005/8/layout/StepDownProcess" loCatId="process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428C44F9-293D-44F5-B871-9185DEAF5E5B}">
      <dgm:prSet phldrT="[Text]"/>
      <dgm:spPr/>
      <dgm:t>
        <a:bodyPr/>
        <a:lstStyle/>
        <a:p>
          <a:r>
            <a:rPr lang="en-GB" dirty="0" smtClean="0"/>
            <a:t>3158</a:t>
          </a:r>
          <a:endParaRPr lang="en-GB" dirty="0"/>
        </a:p>
      </dgm:t>
    </dgm:pt>
    <dgm:pt modelId="{AAFEC447-5BB7-4CF5-B9AE-2851D0241951}" type="parTrans" cxnId="{C068BC39-08EA-4814-90A1-3A3A7FAE1EC0}">
      <dgm:prSet/>
      <dgm:spPr/>
      <dgm:t>
        <a:bodyPr/>
        <a:lstStyle/>
        <a:p>
          <a:endParaRPr lang="en-GB"/>
        </a:p>
      </dgm:t>
    </dgm:pt>
    <dgm:pt modelId="{BD1125FE-18C2-4EDD-B34E-4AED59752224}" type="sibTrans" cxnId="{C068BC39-08EA-4814-90A1-3A3A7FAE1EC0}">
      <dgm:prSet/>
      <dgm:spPr/>
      <dgm:t>
        <a:bodyPr/>
        <a:lstStyle/>
        <a:p>
          <a:endParaRPr lang="en-GB"/>
        </a:p>
      </dgm:t>
    </dgm:pt>
    <dgm:pt modelId="{C983A6B9-68FF-4BA6-A726-BE4BB8B4B974}">
      <dgm:prSet phldrT="[Text]"/>
      <dgm:spPr/>
      <dgm:t>
        <a:bodyPr/>
        <a:lstStyle/>
        <a:p>
          <a:r>
            <a:rPr lang="en-GB" dirty="0" smtClean="0"/>
            <a:t>3151</a:t>
          </a:r>
          <a:endParaRPr lang="en-GB" dirty="0"/>
        </a:p>
      </dgm:t>
    </dgm:pt>
    <dgm:pt modelId="{780F4C5A-5381-478D-A9F3-69B08458EFA7}" type="parTrans" cxnId="{541E3831-D85D-42B4-B573-758D5542C304}">
      <dgm:prSet/>
      <dgm:spPr/>
      <dgm:t>
        <a:bodyPr/>
        <a:lstStyle/>
        <a:p>
          <a:endParaRPr lang="en-GB"/>
        </a:p>
      </dgm:t>
    </dgm:pt>
    <dgm:pt modelId="{02669A6F-2F46-45C0-87E0-0DC2FA38F09C}" type="sibTrans" cxnId="{541E3831-D85D-42B4-B573-758D5542C304}">
      <dgm:prSet/>
      <dgm:spPr/>
      <dgm:t>
        <a:bodyPr/>
        <a:lstStyle/>
        <a:p>
          <a:endParaRPr lang="en-GB"/>
        </a:p>
      </dgm:t>
    </dgm:pt>
    <dgm:pt modelId="{309BF344-C4E8-41A7-9D2E-9B7F4C026518}">
      <dgm:prSet phldrT="[Text]"/>
      <dgm:spPr/>
      <dgm:t>
        <a:bodyPr/>
        <a:lstStyle/>
        <a:p>
          <a:r>
            <a:rPr lang="en-GB" dirty="0" smtClean="0"/>
            <a:t>3130</a:t>
          </a:r>
          <a:endParaRPr lang="en-GB" dirty="0"/>
        </a:p>
      </dgm:t>
    </dgm:pt>
    <dgm:pt modelId="{2F100802-DDF5-440F-B5BA-0C136B6B5181}" type="parTrans" cxnId="{9494749B-8919-400B-8DF5-A5054A6E4DA3}">
      <dgm:prSet/>
      <dgm:spPr/>
      <dgm:t>
        <a:bodyPr/>
        <a:lstStyle/>
        <a:p>
          <a:endParaRPr lang="en-GB"/>
        </a:p>
      </dgm:t>
    </dgm:pt>
    <dgm:pt modelId="{1202D14E-095F-4B80-92AA-819014D97881}" type="sibTrans" cxnId="{9494749B-8919-400B-8DF5-A5054A6E4DA3}">
      <dgm:prSet/>
      <dgm:spPr/>
      <dgm:t>
        <a:bodyPr/>
        <a:lstStyle/>
        <a:p>
          <a:endParaRPr lang="en-GB"/>
        </a:p>
      </dgm:t>
    </dgm:pt>
    <dgm:pt modelId="{7B8D945F-8FCE-4397-9EA9-35B3A3B25BE1}">
      <dgm:prSet/>
      <dgm:spPr/>
      <dgm:t>
        <a:bodyPr/>
        <a:lstStyle/>
        <a:p>
          <a:r>
            <a:rPr lang="en-GB" dirty="0" smtClean="0"/>
            <a:t>2990</a:t>
          </a:r>
          <a:endParaRPr lang="en-GB" dirty="0"/>
        </a:p>
      </dgm:t>
    </dgm:pt>
    <dgm:pt modelId="{E345C336-2085-49DD-BF7D-0D8F7D2B8A0E}" type="parTrans" cxnId="{FB626205-2DD5-4434-9232-1EF932B43F4A}">
      <dgm:prSet/>
      <dgm:spPr/>
      <dgm:t>
        <a:bodyPr/>
        <a:lstStyle/>
        <a:p>
          <a:endParaRPr lang="en-GB"/>
        </a:p>
      </dgm:t>
    </dgm:pt>
    <dgm:pt modelId="{4404C967-26CA-4B25-9F4B-68E0D3B375C0}" type="sibTrans" cxnId="{FB626205-2DD5-4434-9232-1EF932B43F4A}">
      <dgm:prSet/>
      <dgm:spPr/>
      <dgm:t>
        <a:bodyPr/>
        <a:lstStyle/>
        <a:p>
          <a:endParaRPr lang="en-GB"/>
        </a:p>
      </dgm:t>
    </dgm:pt>
    <dgm:pt modelId="{893FA5C5-AE2A-476C-B99C-CFA51CF1F1F3}">
      <dgm:prSet/>
      <dgm:spPr/>
      <dgm:t>
        <a:bodyPr/>
        <a:lstStyle/>
        <a:p>
          <a:r>
            <a:rPr lang="en-GB" dirty="0" smtClean="0"/>
            <a:t>1990</a:t>
          </a:r>
          <a:endParaRPr lang="en-GB" dirty="0"/>
        </a:p>
      </dgm:t>
    </dgm:pt>
    <dgm:pt modelId="{F0C41C3C-FB93-4A09-AB36-FCDA466F0E7C}" type="parTrans" cxnId="{7949FBA9-7AAD-4A05-A752-E5695302321C}">
      <dgm:prSet/>
      <dgm:spPr/>
      <dgm:t>
        <a:bodyPr/>
        <a:lstStyle/>
        <a:p>
          <a:endParaRPr lang="en-GB"/>
        </a:p>
      </dgm:t>
    </dgm:pt>
    <dgm:pt modelId="{AE0B74DE-B09D-497C-9B3F-0142C0561BF4}" type="sibTrans" cxnId="{7949FBA9-7AAD-4A05-A752-E5695302321C}">
      <dgm:prSet/>
      <dgm:spPr/>
      <dgm:t>
        <a:bodyPr/>
        <a:lstStyle/>
        <a:p>
          <a:endParaRPr lang="en-GB"/>
        </a:p>
      </dgm:t>
    </dgm:pt>
    <dgm:pt modelId="{1B12C22E-783C-42C0-A2DC-3ED8F6A82188}">
      <dgm:prSet/>
      <dgm:spPr/>
      <dgm:t>
        <a:bodyPr/>
        <a:lstStyle/>
        <a:p>
          <a:r>
            <a:rPr lang="en-GB" dirty="0" smtClean="0"/>
            <a:t>1982</a:t>
          </a:r>
          <a:endParaRPr lang="en-GB" dirty="0"/>
        </a:p>
      </dgm:t>
    </dgm:pt>
    <dgm:pt modelId="{868F1016-1432-4C4A-A33E-B515131051D0}" type="parTrans" cxnId="{F26F660D-1C9C-4D29-8578-4ACA3A2CBDA8}">
      <dgm:prSet/>
      <dgm:spPr/>
      <dgm:t>
        <a:bodyPr/>
        <a:lstStyle/>
        <a:p>
          <a:endParaRPr lang="en-GB"/>
        </a:p>
      </dgm:t>
    </dgm:pt>
    <dgm:pt modelId="{0FEBDE89-543C-407B-9E3F-CA91768F7C49}" type="sibTrans" cxnId="{F26F660D-1C9C-4D29-8578-4ACA3A2CBDA8}">
      <dgm:prSet/>
      <dgm:spPr/>
      <dgm:t>
        <a:bodyPr/>
        <a:lstStyle/>
        <a:p>
          <a:endParaRPr lang="en-GB"/>
        </a:p>
      </dgm:t>
    </dgm:pt>
    <dgm:pt modelId="{409C638E-C6CD-400B-A9C2-24FFFDD9319F}" type="pres">
      <dgm:prSet presAssocID="{7C36602C-36D2-485B-8966-F939997DAA65}" presName="rootnode" presStyleCnt="0">
        <dgm:presLayoutVars>
          <dgm:chMax/>
          <dgm:chPref/>
          <dgm:dir/>
          <dgm:animLvl val="lvl"/>
        </dgm:presLayoutVars>
      </dgm:prSet>
      <dgm:spPr/>
      <dgm:t>
        <a:bodyPr/>
        <a:lstStyle/>
        <a:p>
          <a:endParaRPr lang="en-GB"/>
        </a:p>
      </dgm:t>
    </dgm:pt>
    <dgm:pt modelId="{E68C44E8-78FF-44E6-BD46-40E4B61084F9}" type="pres">
      <dgm:prSet presAssocID="{428C44F9-293D-44F5-B871-9185DEAF5E5B}" presName="composite" presStyleCnt="0"/>
      <dgm:spPr/>
    </dgm:pt>
    <dgm:pt modelId="{B2103024-F5C7-4637-9EF8-BD450C243870}" type="pres">
      <dgm:prSet presAssocID="{428C44F9-293D-44F5-B871-9185DEAF5E5B}" presName="bentUpArrow1" presStyleLbl="alignImgPlace1" presStyleIdx="0" presStyleCnt="5"/>
      <dgm:spPr/>
    </dgm:pt>
    <dgm:pt modelId="{E926E857-0067-4C2B-A647-6C7AF1C01DD8}" type="pres">
      <dgm:prSet presAssocID="{428C44F9-293D-44F5-B871-9185DEAF5E5B}" presName="ParentText" presStyleLbl="node1" presStyleIdx="0" presStyleCnt="6">
        <dgm:presLayoutVars>
          <dgm:chMax val="1"/>
          <dgm:chPref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CB9F0C5A-72D8-4E86-9646-8F06FF6997C7}" type="pres">
      <dgm:prSet presAssocID="{428C44F9-293D-44F5-B871-9185DEAF5E5B}" presName="ChildText" presStyleLbl="revTx" presStyleIdx="0" presStyleCnt="5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62F8FE1-79CE-49AD-BEA2-50BFDE49628A}" type="pres">
      <dgm:prSet presAssocID="{BD1125FE-18C2-4EDD-B34E-4AED59752224}" presName="sibTrans" presStyleCnt="0"/>
      <dgm:spPr/>
    </dgm:pt>
    <dgm:pt modelId="{A6A29B55-2316-47B0-A2E5-6DD8D28B3B45}" type="pres">
      <dgm:prSet presAssocID="{C983A6B9-68FF-4BA6-A726-BE4BB8B4B974}" presName="composite" presStyleCnt="0"/>
      <dgm:spPr/>
    </dgm:pt>
    <dgm:pt modelId="{3A19152B-4689-4797-AB6C-33889A91AFD5}" type="pres">
      <dgm:prSet presAssocID="{C983A6B9-68FF-4BA6-A726-BE4BB8B4B974}" presName="bentUpArrow1" presStyleLbl="alignImgPlace1" presStyleIdx="1" presStyleCnt="5"/>
      <dgm:spPr/>
    </dgm:pt>
    <dgm:pt modelId="{4F690794-71E8-4703-AF48-8833025EB47D}" type="pres">
      <dgm:prSet presAssocID="{C983A6B9-68FF-4BA6-A726-BE4BB8B4B974}" presName="ParentText" presStyleLbl="node1" presStyleIdx="1" presStyleCnt="6">
        <dgm:presLayoutVars>
          <dgm:chMax val="1"/>
          <dgm:chPref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00B1AF79-7503-48C8-BA66-CCCED8DA66B6}" type="pres">
      <dgm:prSet presAssocID="{C983A6B9-68FF-4BA6-A726-BE4BB8B4B974}" presName="ChildText" presStyleLbl="revTx" presStyleIdx="1" presStyleCnt="5" custScaleX="168623" custScaleY="70592" custLinFactX="-143798" custLinFactNeighborX="-200000" custLinFactNeighborY="23287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8CC31EBB-B9AF-4C37-8D6C-AEF29007CD23}" type="pres">
      <dgm:prSet presAssocID="{02669A6F-2F46-45C0-87E0-0DC2FA38F09C}" presName="sibTrans" presStyleCnt="0"/>
      <dgm:spPr/>
    </dgm:pt>
    <dgm:pt modelId="{F30812BC-ABD7-4CE5-BCA2-86EF5E49A157}" type="pres">
      <dgm:prSet presAssocID="{309BF344-C4E8-41A7-9D2E-9B7F4C026518}" presName="composite" presStyleCnt="0"/>
      <dgm:spPr/>
    </dgm:pt>
    <dgm:pt modelId="{F9B9F8CB-F760-4868-913F-91F51F284CF3}" type="pres">
      <dgm:prSet presAssocID="{309BF344-C4E8-41A7-9D2E-9B7F4C026518}" presName="bentUpArrow1" presStyleLbl="alignImgPlace1" presStyleIdx="2" presStyleCnt="5"/>
      <dgm:spPr/>
    </dgm:pt>
    <dgm:pt modelId="{4110FC24-5EF1-47AF-8719-0ED4087A0966}" type="pres">
      <dgm:prSet presAssocID="{309BF344-C4E8-41A7-9D2E-9B7F4C026518}" presName="ParentText" presStyleLbl="node1" presStyleIdx="2" presStyleCnt="6">
        <dgm:presLayoutVars>
          <dgm:chMax val="1"/>
          <dgm:chPref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D57098C6-B37F-4ACE-91EC-386503A945EE}" type="pres">
      <dgm:prSet presAssocID="{309BF344-C4E8-41A7-9D2E-9B7F4C026518}" presName="ChildText" presStyleLbl="revTx" presStyleIdx="2" presStyleCnt="5" custScaleY="70593" custLinFactNeighborX="11126" custLinFactNeighborY="1929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23C891D2-0CBA-4097-9BEE-ED5958FFD3B2}" type="pres">
      <dgm:prSet presAssocID="{1202D14E-095F-4B80-92AA-819014D97881}" presName="sibTrans" presStyleCnt="0"/>
      <dgm:spPr/>
    </dgm:pt>
    <dgm:pt modelId="{2DABAF2F-9408-4AD3-BA04-8AB7FB993864}" type="pres">
      <dgm:prSet presAssocID="{7B8D945F-8FCE-4397-9EA9-35B3A3B25BE1}" presName="composite" presStyleCnt="0"/>
      <dgm:spPr/>
    </dgm:pt>
    <dgm:pt modelId="{5CCD2825-8763-4DAD-8960-60246BBE9B91}" type="pres">
      <dgm:prSet presAssocID="{7B8D945F-8FCE-4397-9EA9-35B3A3B25BE1}" presName="bentUpArrow1" presStyleLbl="alignImgPlace1" presStyleIdx="3" presStyleCnt="5"/>
      <dgm:spPr/>
    </dgm:pt>
    <dgm:pt modelId="{9E89ABFE-B7E4-47DF-81D6-7D0690852728}" type="pres">
      <dgm:prSet presAssocID="{7B8D945F-8FCE-4397-9EA9-35B3A3B25BE1}" presName="ParentText" presStyleLbl="node1" presStyleIdx="3" presStyleCnt="6">
        <dgm:presLayoutVars>
          <dgm:chMax val="1"/>
          <dgm:chPref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F05D76AC-314B-4B2A-9FC2-623EE4E02F2F}" type="pres">
      <dgm:prSet presAssocID="{7B8D945F-8FCE-4397-9EA9-35B3A3B25BE1}" presName="ChildText" presStyleLbl="revTx" presStyleIdx="3" presStyleCnt="5">
        <dgm:presLayoutVars>
          <dgm:chMax val="0"/>
          <dgm:chPref val="0"/>
          <dgm:bulletEnabled val="1"/>
        </dgm:presLayoutVars>
      </dgm:prSet>
      <dgm:spPr/>
    </dgm:pt>
    <dgm:pt modelId="{73598F33-157A-4821-BA94-CC9283C3CE5F}" type="pres">
      <dgm:prSet presAssocID="{4404C967-26CA-4B25-9F4B-68E0D3B375C0}" presName="sibTrans" presStyleCnt="0"/>
      <dgm:spPr/>
    </dgm:pt>
    <dgm:pt modelId="{7536E5B6-0C25-468B-9DFC-653F362F367D}" type="pres">
      <dgm:prSet presAssocID="{893FA5C5-AE2A-476C-B99C-CFA51CF1F1F3}" presName="composite" presStyleCnt="0"/>
      <dgm:spPr/>
    </dgm:pt>
    <dgm:pt modelId="{0743B869-7102-4404-8770-0707695771C6}" type="pres">
      <dgm:prSet presAssocID="{893FA5C5-AE2A-476C-B99C-CFA51CF1F1F3}" presName="bentUpArrow1" presStyleLbl="alignImgPlace1" presStyleIdx="4" presStyleCnt="5"/>
      <dgm:spPr/>
    </dgm:pt>
    <dgm:pt modelId="{4C382440-7077-485D-A309-97A992133D63}" type="pres">
      <dgm:prSet presAssocID="{893FA5C5-AE2A-476C-B99C-CFA51CF1F1F3}" presName="ParentText" presStyleLbl="node1" presStyleIdx="4" presStyleCnt="6">
        <dgm:presLayoutVars>
          <dgm:chMax val="1"/>
          <dgm:chPref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847B58DE-F5D1-4FB0-B071-8BAE151E6E48}" type="pres">
      <dgm:prSet presAssocID="{893FA5C5-AE2A-476C-B99C-CFA51CF1F1F3}" presName="ChildText" presStyleLbl="revTx" presStyleIdx="4" presStyleCnt="5">
        <dgm:presLayoutVars>
          <dgm:chMax val="0"/>
          <dgm:chPref val="0"/>
          <dgm:bulletEnabled val="1"/>
        </dgm:presLayoutVars>
      </dgm:prSet>
      <dgm:spPr/>
    </dgm:pt>
    <dgm:pt modelId="{C23DA9BD-9D54-4165-98B7-E99864A8D06B}" type="pres">
      <dgm:prSet presAssocID="{AE0B74DE-B09D-497C-9B3F-0142C0561BF4}" presName="sibTrans" presStyleCnt="0"/>
      <dgm:spPr/>
    </dgm:pt>
    <dgm:pt modelId="{1AF003FC-BC93-4BC3-BD94-5286C9AD5166}" type="pres">
      <dgm:prSet presAssocID="{1B12C22E-783C-42C0-A2DC-3ED8F6A82188}" presName="composite" presStyleCnt="0"/>
      <dgm:spPr/>
    </dgm:pt>
    <dgm:pt modelId="{7B46DC20-C7C6-4C2A-8D25-90515BC45CF3}" type="pres">
      <dgm:prSet presAssocID="{1B12C22E-783C-42C0-A2DC-3ED8F6A82188}" presName="ParentText" presStyleLbl="node1" presStyleIdx="5" presStyleCnt="6">
        <dgm:presLayoutVars>
          <dgm:chMax val="1"/>
          <dgm:chPref val="1"/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468DE7FA-B5F5-4A9F-800B-AE8F03780C49}" type="presOf" srcId="{428C44F9-293D-44F5-B871-9185DEAF5E5B}" destId="{E926E857-0067-4C2B-A647-6C7AF1C01DD8}" srcOrd="0" destOrd="0" presId="urn:microsoft.com/office/officeart/2005/8/layout/StepDownProcess"/>
    <dgm:cxn modelId="{5292EED3-EA2A-49D9-BB7C-53279B9507F2}" type="presOf" srcId="{7B8D945F-8FCE-4397-9EA9-35B3A3B25BE1}" destId="{9E89ABFE-B7E4-47DF-81D6-7D0690852728}" srcOrd="0" destOrd="0" presId="urn:microsoft.com/office/officeart/2005/8/layout/StepDownProcess"/>
    <dgm:cxn modelId="{1093B3D2-2CC6-40CD-93A5-858BAB4B2404}" type="presOf" srcId="{7C36602C-36D2-485B-8966-F939997DAA65}" destId="{409C638E-C6CD-400B-A9C2-24FFFDD9319F}" srcOrd="0" destOrd="0" presId="urn:microsoft.com/office/officeart/2005/8/layout/StepDownProcess"/>
    <dgm:cxn modelId="{F086255E-101F-43CC-ABD1-793C698CA4EA}" type="presOf" srcId="{C983A6B9-68FF-4BA6-A726-BE4BB8B4B974}" destId="{4F690794-71E8-4703-AF48-8833025EB47D}" srcOrd="0" destOrd="0" presId="urn:microsoft.com/office/officeart/2005/8/layout/StepDownProcess"/>
    <dgm:cxn modelId="{9494749B-8919-400B-8DF5-A5054A6E4DA3}" srcId="{7C36602C-36D2-485B-8966-F939997DAA65}" destId="{309BF344-C4E8-41A7-9D2E-9B7F4C026518}" srcOrd="2" destOrd="0" parTransId="{2F100802-DDF5-440F-B5BA-0C136B6B5181}" sibTransId="{1202D14E-095F-4B80-92AA-819014D97881}"/>
    <dgm:cxn modelId="{C068BC39-08EA-4814-90A1-3A3A7FAE1EC0}" srcId="{7C36602C-36D2-485B-8966-F939997DAA65}" destId="{428C44F9-293D-44F5-B871-9185DEAF5E5B}" srcOrd="0" destOrd="0" parTransId="{AAFEC447-5BB7-4CF5-B9AE-2851D0241951}" sibTransId="{BD1125FE-18C2-4EDD-B34E-4AED59752224}"/>
    <dgm:cxn modelId="{7949FBA9-7AAD-4A05-A752-E5695302321C}" srcId="{7C36602C-36D2-485B-8966-F939997DAA65}" destId="{893FA5C5-AE2A-476C-B99C-CFA51CF1F1F3}" srcOrd="4" destOrd="0" parTransId="{F0C41C3C-FB93-4A09-AB36-FCDA466F0E7C}" sibTransId="{AE0B74DE-B09D-497C-9B3F-0142C0561BF4}"/>
    <dgm:cxn modelId="{CC399B42-D3EF-4955-813D-853DCFA9E5B8}" type="presOf" srcId="{309BF344-C4E8-41A7-9D2E-9B7F4C026518}" destId="{4110FC24-5EF1-47AF-8719-0ED4087A0966}" srcOrd="0" destOrd="0" presId="urn:microsoft.com/office/officeart/2005/8/layout/StepDownProcess"/>
    <dgm:cxn modelId="{722DC3CD-8CF6-4A79-AA5E-5FC4380A929F}" type="presOf" srcId="{893FA5C5-AE2A-476C-B99C-CFA51CF1F1F3}" destId="{4C382440-7077-485D-A309-97A992133D63}" srcOrd="0" destOrd="0" presId="urn:microsoft.com/office/officeart/2005/8/layout/StepDownProcess"/>
    <dgm:cxn modelId="{541E3831-D85D-42B4-B573-758D5542C304}" srcId="{7C36602C-36D2-485B-8966-F939997DAA65}" destId="{C983A6B9-68FF-4BA6-A726-BE4BB8B4B974}" srcOrd="1" destOrd="0" parTransId="{780F4C5A-5381-478D-A9F3-69B08458EFA7}" sibTransId="{02669A6F-2F46-45C0-87E0-0DC2FA38F09C}"/>
    <dgm:cxn modelId="{3A5ECE65-172D-4035-8D31-07267E49E609}" type="presOf" srcId="{1B12C22E-783C-42C0-A2DC-3ED8F6A82188}" destId="{7B46DC20-C7C6-4C2A-8D25-90515BC45CF3}" srcOrd="0" destOrd="0" presId="urn:microsoft.com/office/officeart/2005/8/layout/StepDownProcess"/>
    <dgm:cxn modelId="{F26F660D-1C9C-4D29-8578-4ACA3A2CBDA8}" srcId="{7C36602C-36D2-485B-8966-F939997DAA65}" destId="{1B12C22E-783C-42C0-A2DC-3ED8F6A82188}" srcOrd="5" destOrd="0" parTransId="{868F1016-1432-4C4A-A33E-B515131051D0}" sibTransId="{0FEBDE89-543C-407B-9E3F-CA91768F7C49}"/>
    <dgm:cxn modelId="{FB626205-2DD5-4434-9232-1EF932B43F4A}" srcId="{7C36602C-36D2-485B-8966-F939997DAA65}" destId="{7B8D945F-8FCE-4397-9EA9-35B3A3B25BE1}" srcOrd="3" destOrd="0" parTransId="{E345C336-2085-49DD-BF7D-0D8F7D2B8A0E}" sibTransId="{4404C967-26CA-4B25-9F4B-68E0D3B375C0}"/>
    <dgm:cxn modelId="{A5B55F9D-D904-4AB5-899D-670AC50D2777}" type="presParOf" srcId="{409C638E-C6CD-400B-A9C2-24FFFDD9319F}" destId="{E68C44E8-78FF-44E6-BD46-40E4B61084F9}" srcOrd="0" destOrd="0" presId="urn:microsoft.com/office/officeart/2005/8/layout/StepDownProcess"/>
    <dgm:cxn modelId="{DF1EE6C1-4FF6-4786-B3AB-60F4EEAEC4E8}" type="presParOf" srcId="{E68C44E8-78FF-44E6-BD46-40E4B61084F9}" destId="{B2103024-F5C7-4637-9EF8-BD450C243870}" srcOrd="0" destOrd="0" presId="urn:microsoft.com/office/officeart/2005/8/layout/StepDownProcess"/>
    <dgm:cxn modelId="{6C7BDAC1-CFC3-4FEB-9420-C486580BD8C2}" type="presParOf" srcId="{E68C44E8-78FF-44E6-BD46-40E4B61084F9}" destId="{E926E857-0067-4C2B-A647-6C7AF1C01DD8}" srcOrd="1" destOrd="0" presId="urn:microsoft.com/office/officeart/2005/8/layout/StepDownProcess"/>
    <dgm:cxn modelId="{16AC753A-1A3C-4E5F-AF82-AC8983EB9D36}" type="presParOf" srcId="{E68C44E8-78FF-44E6-BD46-40E4B61084F9}" destId="{CB9F0C5A-72D8-4E86-9646-8F06FF6997C7}" srcOrd="2" destOrd="0" presId="urn:microsoft.com/office/officeart/2005/8/layout/StepDownProcess"/>
    <dgm:cxn modelId="{981CA9AC-5D18-4F5F-871D-1B420C957616}" type="presParOf" srcId="{409C638E-C6CD-400B-A9C2-24FFFDD9319F}" destId="{B62F8FE1-79CE-49AD-BEA2-50BFDE49628A}" srcOrd="1" destOrd="0" presId="urn:microsoft.com/office/officeart/2005/8/layout/StepDownProcess"/>
    <dgm:cxn modelId="{6EBB4911-D78C-4CCF-A91C-E5E54D76F8DB}" type="presParOf" srcId="{409C638E-C6CD-400B-A9C2-24FFFDD9319F}" destId="{A6A29B55-2316-47B0-A2E5-6DD8D28B3B45}" srcOrd="2" destOrd="0" presId="urn:microsoft.com/office/officeart/2005/8/layout/StepDownProcess"/>
    <dgm:cxn modelId="{D421069A-E877-48B7-BBCB-E960884BD8AF}" type="presParOf" srcId="{A6A29B55-2316-47B0-A2E5-6DD8D28B3B45}" destId="{3A19152B-4689-4797-AB6C-33889A91AFD5}" srcOrd="0" destOrd="0" presId="urn:microsoft.com/office/officeart/2005/8/layout/StepDownProcess"/>
    <dgm:cxn modelId="{81B73B79-BE1E-4614-A1D0-3C440903F22C}" type="presParOf" srcId="{A6A29B55-2316-47B0-A2E5-6DD8D28B3B45}" destId="{4F690794-71E8-4703-AF48-8833025EB47D}" srcOrd="1" destOrd="0" presId="urn:microsoft.com/office/officeart/2005/8/layout/StepDownProcess"/>
    <dgm:cxn modelId="{1A658134-241E-4181-A3CB-44A112E1D195}" type="presParOf" srcId="{A6A29B55-2316-47B0-A2E5-6DD8D28B3B45}" destId="{00B1AF79-7503-48C8-BA66-CCCED8DA66B6}" srcOrd="2" destOrd="0" presId="urn:microsoft.com/office/officeart/2005/8/layout/StepDownProcess"/>
    <dgm:cxn modelId="{97DCC997-27B0-437C-B4F3-8C83E9DB89C5}" type="presParOf" srcId="{409C638E-C6CD-400B-A9C2-24FFFDD9319F}" destId="{8CC31EBB-B9AF-4C37-8D6C-AEF29007CD23}" srcOrd="3" destOrd="0" presId="urn:microsoft.com/office/officeart/2005/8/layout/StepDownProcess"/>
    <dgm:cxn modelId="{2B8131E0-9022-408C-B544-F110FAF60D3F}" type="presParOf" srcId="{409C638E-C6CD-400B-A9C2-24FFFDD9319F}" destId="{F30812BC-ABD7-4CE5-BCA2-86EF5E49A157}" srcOrd="4" destOrd="0" presId="urn:microsoft.com/office/officeart/2005/8/layout/StepDownProcess"/>
    <dgm:cxn modelId="{8E89A876-0DA7-47FA-9B96-478E7D3F3549}" type="presParOf" srcId="{F30812BC-ABD7-4CE5-BCA2-86EF5E49A157}" destId="{F9B9F8CB-F760-4868-913F-91F51F284CF3}" srcOrd="0" destOrd="0" presId="urn:microsoft.com/office/officeart/2005/8/layout/StepDownProcess"/>
    <dgm:cxn modelId="{6DE75E0F-913B-4E35-B9C0-3A929EE4FD17}" type="presParOf" srcId="{F30812BC-ABD7-4CE5-BCA2-86EF5E49A157}" destId="{4110FC24-5EF1-47AF-8719-0ED4087A0966}" srcOrd="1" destOrd="0" presId="urn:microsoft.com/office/officeart/2005/8/layout/StepDownProcess"/>
    <dgm:cxn modelId="{47C26C7C-C095-44E4-A6E8-60A3E3A5242D}" type="presParOf" srcId="{F30812BC-ABD7-4CE5-BCA2-86EF5E49A157}" destId="{D57098C6-B37F-4ACE-91EC-386503A945EE}" srcOrd="2" destOrd="0" presId="urn:microsoft.com/office/officeart/2005/8/layout/StepDownProcess"/>
    <dgm:cxn modelId="{36223277-AB5A-448D-8C98-C4F202F39BE1}" type="presParOf" srcId="{409C638E-C6CD-400B-A9C2-24FFFDD9319F}" destId="{23C891D2-0CBA-4097-9BEE-ED5958FFD3B2}" srcOrd="5" destOrd="0" presId="urn:microsoft.com/office/officeart/2005/8/layout/StepDownProcess"/>
    <dgm:cxn modelId="{99E3B2B7-037F-4E06-9196-ACE00A404392}" type="presParOf" srcId="{409C638E-C6CD-400B-A9C2-24FFFDD9319F}" destId="{2DABAF2F-9408-4AD3-BA04-8AB7FB993864}" srcOrd="6" destOrd="0" presId="urn:microsoft.com/office/officeart/2005/8/layout/StepDownProcess"/>
    <dgm:cxn modelId="{555C5A53-CC76-477A-B99F-43541CB77377}" type="presParOf" srcId="{2DABAF2F-9408-4AD3-BA04-8AB7FB993864}" destId="{5CCD2825-8763-4DAD-8960-60246BBE9B91}" srcOrd="0" destOrd="0" presId="urn:microsoft.com/office/officeart/2005/8/layout/StepDownProcess"/>
    <dgm:cxn modelId="{0243054A-7664-458D-86C1-65912DDBFB89}" type="presParOf" srcId="{2DABAF2F-9408-4AD3-BA04-8AB7FB993864}" destId="{9E89ABFE-B7E4-47DF-81D6-7D0690852728}" srcOrd="1" destOrd="0" presId="urn:microsoft.com/office/officeart/2005/8/layout/StepDownProcess"/>
    <dgm:cxn modelId="{AE58EFE1-6664-44C7-BC04-B4D504A79DBE}" type="presParOf" srcId="{2DABAF2F-9408-4AD3-BA04-8AB7FB993864}" destId="{F05D76AC-314B-4B2A-9FC2-623EE4E02F2F}" srcOrd="2" destOrd="0" presId="urn:microsoft.com/office/officeart/2005/8/layout/StepDownProcess"/>
    <dgm:cxn modelId="{C526A394-2081-49E0-9091-CEF18E11902A}" type="presParOf" srcId="{409C638E-C6CD-400B-A9C2-24FFFDD9319F}" destId="{73598F33-157A-4821-BA94-CC9283C3CE5F}" srcOrd="7" destOrd="0" presId="urn:microsoft.com/office/officeart/2005/8/layout/StepDownProcess"/>
    <dgm:cxn modelId="{44B927EC-D280-4CBC-B639-176DD2C78CF6}" type="presParOf" srcId="{409C638E-C6CD-400B-A9C2-24FFFDD9319F}" destId="{7536E5B6-0C25-468B-9DFC-653F362F367D}" srcOrd="8" destOrd="0" presId="urn:microsoft.com/office/officeart/2005/8/layout/StepDownProcess"/>
    <dgm:cxn modelId="{8E6CAC04-FCB5-4795-AE71-DF15FA4DFAB5}" type="presParOf" srcId="{7536E5B6-0C25-468B-9DFC-653F362F367D}" destId="{0743B869-7102-4404-8770-0707695771C6}" srcOrd="0" destOrd="0" presId="urn:microsoft.com/office/officeart/2005/8/layout/StepDownProcess"/>
    <dgm:cxn modelId="{D1AAC91B-2A6D-47D0-B8E9-6703A5E5B7E2}" type="presParOf" srcId="{7536E5B6-0C25-468B-9DFC-653F362F367D}" destId="{4C382440-7077-485D-A309-97A992133D63}" srcOrd="1" destOrd="0" presId="urn:microsoft.com/office/officeart/2005/8/layout/StepDownProcess"/>
    <dgm:cxn modelId="{AA48A347-4102-4ABF-809E-0E0B04858C18}" type="presParOf" srcId="{7536E5B6-0C25-468B-9DFC-653F362F367D}" destId="{847B58DE-F5D1-4FB0-B071-8BAE151E6E48}" srcOrd="2" destOrd="0" presId="urn:microsoft.com/office/officeart/2005/8/layout/StepDownProcess"/>
    <dgm:cxn modelId="{2C5BE4EC-F476-4201-9516-A07B2D088520}" type="presParOf" srcId="{409C638E-C6CD-400B-A9C2-24FFFDD9319F}" destId="{C23DA9BD-9D54-4165-98B7-E99864A8D06B}" srcOrd="9" destOrd="0" presId="urn:microsoft.com/office/officeart/2005/8/layout/StepDownProcess"/>
    <dgm:cxn modelId="{EC8757CC-DD83-4518-8EB1-16D371840BE3}" type="presParOf" srcId="{409C638E-C6CD-400B-A9C2-24FFFDD9319F}" destId="{1AF003FC-BC93-4BC3-BD94-5286C9AD5166}" srcOrd="10" destOrd="0" presId="urn:microsoft.com/office/officeart/2005/8/layout/StepDownProcess"/>
    <dgm:cxn modelId="{7AC63060-8DD7-465A-91BC-AAC01F10F451}" type="presParOf" srcId="{1AF003FC-BC93-4BC3-BD94-5286C9AD5166}" destId="{7B46DC20-C7C6-4C2A-8D25-90515BC45CF3}" srcOrd="0" destOrd="0" presId="urn:microsoft.com/office/officeart/2005/8/layout/StepDownProces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2103024-F5C7-4637-9EF8-BD450C243870}">
      <dsp:nvSpPr>
        <dsp:cNvPr id="0" name=""/>
        <dsp:cNvSpPr/>
      </dsp:nvSpPr>
      <dsp:spPr>
        <a:xfrm rot="5400000">
          <a:off x="957094" y="597403"/>
          <a:ext cx="514230" cy="585433"/>
        </a:xfrm>
        <a:prstGeom prst="bentUpArrow">
          <a:avLst>
            <a:gd name="adj1" fmla="val 32840"/>
            <a:gd name="adj2" fmla="val 25000"/>
            <a:gd name="adj3" fmla="val 35780"/>
          </a:avLst>
        </a:prstGeom>
        <a:solidFill>
          <a:schemeClr val="accent1">
            <a:tint val="5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E926E857-0067-4C2B-A647-6C7AF1C01DD8}">
      <dsp:nvSpPr>
        <dsp:cNvPr id="0" name=""/>
        <dsp:cNvSpPr/>
      </dsp:nvSpPr>
      <dsp:spPr>
        <a:xfrm>
          <a:off x="820854" y="27368"/>
          <a:ext cx="865662" cy="605935"/>
        </a:xfrm>
        <a:prstGeom prst="roundRect">
          <a:avLst>
            <a:gd name="adj" fmla="val 1667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1440" tIns="91440" rIns="91440" bIns="91440" numCol="1" spcCol="1270" anchor="ctr" anchorCtr="0">
          <a:noAutofit/>
        </a:bodyPr>
        <a:lstStyle/>
        <a:p>
          <a:pPr lvl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400" kern="1200" dirty="0" smtClean="0"/>
            <a:t>3158</a:t>
          </a:r>
          <a:endParaRPr lang="en-GB" sz="2400" kern="1200" dirty="0"/>
        </a:p>
      </dsp:txBody>
      <dsp:txXfrm>
        <a:off x="850439" y="56953"/>
        <a:ext cx="806492" cy="546765"/>
      </dsp:txXfrm>
    </dsp:sp>
    <dsp:sp modelId="{CB9F0C5A-72D8-4E86-9646-8F06FF6997C7}">
      <dsp:nvSpPr>
        <dsp:cNvPr id="0" name=""/>
        <dsp:cNvSpPr/>
      </dsp:nvSpPr>
      <dsp:spPr>
        <a:xfrm>
          <a:off x="1686516" y="85158"/>
          <a:ext cx="629600" cy="48974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A19152B-4689-4797-AB6C-33889A91AFD5}">
      <dsp:nvSpPr>
        <dsp:cNvPr id="0" name=""/>
        <dsp:cNvSpPr/>
      </dsp:nvSpPr>
      <dsp:spPr>
        <a:xfrm rot="5400000">
          <a:off x="1674819" y="1278069"/>
          <a:ext cx="514230" cy="585433"/>
        </a:xfrm>
        <a:prstGeom prst="bentUpArrow">
          <a:avLst>
            <a:gd name="adj1" fmla="val 32840"/>
            <a:gd name="adj2" fmla="val 25000"/>
            <a:gd name="adj3" fmla="val 35780"/>
          </a:avLst>
        </a:prstGeom>
        <a:solidFill>
          <a:schemeClr val="accent1">
            <a:tint val="5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F690794-71E8-4703-AF48-8833025EB47D}">
      <dsp:nvSpPr>
        <dsp:cNvPr id="0" name=""/>
        <dsp:cNvSpPr/>
      </dsp:nvSpPr>
      <dsp:spPr>
        <a:xfrm>
          <a:off x="1538579" y="708034"/>
          <a:ext cx="865662" cy="605935"/>
        </a:xfrm>
        <a:prstGeom prst="roundRect">
          <a:avLst>
            <a:gd name="adj" fmla="val 1667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1440" tIns="91440" rIns="91440" bIns="91440" numCol="1" spcCol="1270" anchor="ctr" anchorCtr="0">
          <a:noAutofit/>
        </a:bodyPr>
        <a:lstStyle/>
        <a:p>
          <a:pPr lvl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400" kern="1200" dirty="0" smtClean="0"/>
            <a:t>3151</a:t>
          </a:r>
          <a:endParaRPr lang="en-GB" sz="2400" kern="1200" dirty="0"/>
        </a:p>
      </dsp:txBody>
      <dsp:txXfrm>
        <a:off x="1568164" y="737619"/>
        <a:ext cx="806492" cy="546765"/>
      </dsp:txXfrm>
    </dsp:sp>
    <dsp:sp modelId="{00B1AF79-7503-48C8-BA66-CCCED8DA66B6}">
      <dsp:nvSpPr>
        <dsp:cNvPr id="0" name=""/>
        <dsp:cNvSpPr/>
      </dsp:nvSpPr>
      <dsp:spPr>
        <a:xfrm>
          <a:off x="23664" y="951882"/>
          <a:ext cx="1061650" cy="345719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9B9F8CB-F760-4868-913F-91F51F284CF3}">
      <dsp:nvSpPr>
        <dsp:cNvPr id="0" name=""/>
        <dsp:cNvSpPr/>
      </dsp:nvSpPr>
      <dsp:spPr>
        <a:xfrm rot="5400000">
          <a:off x="2392545" y="1958734"/>
          <a:ext cx="514230" cy="585433"/>
        </a:xfrm>
        <a:prstGeom prst="bentUpArrow">
          <a:avLst>
            <a:gd name="adj1" fmla="val 32840"/>
            <a:gd name="adj2" fmla="val 25000"/>
            <a:gd name="adj3" fmla="val 35780"/>
          </a:avLst>
        </a:prstGeom>
        <a:solidFill>
          <a:schemeClr val="accent1">
            <a:tint val="5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110FC24-5EF1-47AF-8719-0ED4087A0966}">
      <dsp:nvSpPr>
        <dsp:cNvPr id="0" name=""/>
        <dsp:cNvSpPr/>
      </dsp:nvSpPr>
      <dsp:spPr>
        <a:xfrm>
          <a:off x="2256305" y="1388699"/>
          <a:ext cx="865662" cy="605935"/>
        </a:xfrm>
        <a:prstGeom prst="roundRect">
          <a:avLst>
            <a:gd name="adj" fmla="val 1667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1440" tIns="91440" rIns="91440" bIns="91440" numCol="1" spcCol="1270" anchor="ctr" anchorCtr="0">
          <a:noAutofit/>
        </a:bodyPr>
        <a:lstStyle/>
        <a:p>
          <a:pPr lvl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400" kern="1200" dirty="0" smtClean="0"/>
            <a:t>3130</a:t>
          </a:r>
          <a:endParaRPr lang="en-GB" sz="2400" kern="1200" dirty="0"/>
        </a:p>
      </dsp:txBody>
      <dsp:txXfrm>
        <a:off x="2285890" y="1418284"/>
        <a:ext cx="806492" cy="546765"/>
      </dsp:txXfrm>
    </dsp:sp>
    <dsp:sp modelId="{D57098C6-B37F-4ACE-91EC-386503A945EE}">
      <dsp:nvSpPr>
        <dsp:cNvPr id="0" name=""/>
        <dsp:cNvSpPr/>
      </dsp:nvSpPr>
      <dsp:spPr>
        <a:xfrm>
          <a:off x="3192017" y="1527945"/>
          <a:ext cx="629600" cy="34572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CCD2825-8763-4DAD-8960-60246BBE9B91}">
      <dsp:nvSpPr>
        <dsp:cNvPr id="0" name=""/>
        <dsp:cNvSpPr/>
      </dsp:nvSpPr>
      <dsp:spPr>
        <a:xfrm rot="5400000">
          <a:off x="3110271" y="2639400"/>
          <a:ext cx="514230" cy="585433"/>
        </a:xfrm>
        <a:prstGeom prst="bentUpArrow">
          <a:avLst>
            <a:gd name="adj1" fmla="val 32840"/>
            <a:gd name="adj2" fmla="val 25000"/>
            <a:gd name="adj3" fmla="val 35780"/>
          </a:avLst>
        </a:prstGeom>
        <a:solidFill>
          <a:schemeClr val="accent1">
            <a:tint val="5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E89ABFE-B7E4-47DF-81D6-7D0690852728}">
      <dsp:nvSpPr>
        <dsp:cNvPr id="0" name=""/>
        <dsp:cNvSpPr/>
      </dsp:nvSpPr>
      <dsp:spPr>
        <a:xfrm>
          <a:off x="2974031" y="2069364"/>
          <a:ext cx="865662" cy="605935"/>
        </a:xfrm>
        <a:prstGeom prst="roundRect">
          <a:avLst>
            <a:gd name="adj" fmla="val 1667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1440" tIns="91440" rIns="91440" bIns="91440" numCol="1" spcCol="1270" anchor="ctr" anchorCtr="0">
          <a:noAutofit/>
        </a:bodyPr>
        <a:lstStyle/>
        <a:p>
          <a:pPr lvl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400" kern="1200" dirty="0" smtClean="0"/>
            <a:t>2990</a:t>
          </a:r>
          <a:endParaRPr lang="en-GB" sz="2400" kern="1200" dirty="0"/>
        </a:p>
      </dsp:txBody>
      <dsp:txXfrm>
        <a:off x="3003616" y="2098949"/>
        <a:ext cx="806492" cy="546765"/>
      </dsp:txXfrm>
    </dsp:sp>
    <dsp:sp modelId="{F05D76AC-314B-4B2A-9FC2-623EE4E02F2F}">
      <dsp:nvSpPr>
        <dsp:cNvPr id="0" name=""/>
        <dsp:cNvSpPr/>
      </dsp:nvSpPr>
      <dsp:spPr>
        <a:xfrm>
          <a:off x="3839694" y="2127154"/>
          <a:ext cx="629600" cy="48974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743B869-7102-4404-8770-0707695771C6}">
      <dsp:nvSpPr>
        <dsp:cNvPr id="0" name=""/>
        <dsp:cNvSpPr/>
      </dsp:nvSpPr>
      <dsp:spPr>
        <a:xfrm rot="5400000">
          <a:off x="3827997" y="3320065"/>
          <a:ext cx="514230" cy="585433"/>
        </a:xfrm>
        <a:prstGeom prst="bentUpArrow">
          <a:avLst>
            <a:gd name="adj1" fmla="val 32840"/>
            <a:gd name="adj2" fmla="val 25000"/>
            <a:gd name="adj3" fmla="val 35780"/>
          </a:avLst>
        </a:prstGeom>
        <a:solidFill>
          <a:schemeClr val="accent1">
            <a:tint val="5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C382440-7077-485D-A309-97A992133D63}">
      <dsp:nvSpPr>
        <dsp:cNvPr id="0" name=""/>
        <dsp:cNvSpPr/>
      </dsp:nvSpPr>
      <dsp:spPr>
        <a:xfrm>
          <a:off x="3691757" y="2750030"/>
          <a:ext cx="865662" cy="605935"/>
        </a:xfrm>
        <a:prstGeom prst="roundRect">
          <a:avLst>
            <a:gd name="adj" fmla="val 1667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1440" tIns="91440" rIns="91440" bIns="91440" numCol="1" spcCol="1270" anchor="ctr" anchorCtr="0">
          <a:noAutofit/>
        </a:bodyPr>
        <a:lstStyle/>
        <a:p>
          <a:pPr lvl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400" kern="1200" dirty="0" smtClean="0"/>
            <a:t>1990</a:t>
          </a:r>
          <a:endParaRPr lang="en-GB" sz="2400" kern="1200" dirty="0"/>
        </a:p>
      </dsp:txBody>
      <dsp:txXfrm>
        <a:off x="3721342" y="2779615"/>
        <a:ext cx="806492" cy="546765"/>
      </dsp:txXfrm>
    </dsp:sp>
    <dsp:sp modelId="{847B58DE-F5D1-4FB0-B071-8BAE151E6E48}">
      <dsp:nvSpPr>
        <dsp:cNvPr id="0" name=""/>
        <dsp:cNvSpPr/>
      </dsp:nvSpPr>
      <dsp:spPr>
        <a:xfrm>
          <a:off x="4557420" y="2807820"/>
          <a:ext cx="629600" cy="48974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B46DC20-C7C6-4C2A-8D25-90515BC45CF3}">
      <dsp:nvSpPr>
        <dsp:cNvPr id="0" name=""/>
        <dsp:cNvSpPr/>
      </dsp:nvSpPr>
      <dsp:spPr>
        <a:xfrm>
          <a:off x="4409483" y="3430695"/>
          <a:ext cx="865662" cy="605935"/>
        </a:xfrm>
        <a:prstGeom prst="roundRect">
          <a:avLst>
            <a:gd name="adj" fmla="val 1667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1440" tIns="91440" rIns="91440" bIns="91440" numCol="1" spcCol="1270" anchor="ctr" anchorCtr="0">
          <a:noAutofit/>
        </a:bodyPr>
        <a:lstStyle/>
        <a:p>
          <a:pPr lvl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2400" kern="1200" dirty="0" smtClean="0"/>
            <a:t>1982</a:t>
          </a:r>
          <a:endParaRPr lang="en-GB" sz="2400" kern="1200" dirty="0"/>
        </a:p>
      </dsp:txBody>
      <dsp:txXfrm>
        <a:off x="4439068" y="3460280"/>
        <a:ext cx="806492" cy="546765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StepDownProcess">
  <dgm:title val=""/>
  <dgm:desc val=""/>
  <dgm:catLst>
    <dgm:cat type="process" pri="16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20">
          <dgm:prSet phldr="1"/>
        </dgm:pt>
      </dgm:ptLst>
      <dgm:cxnLst>
        <dgm:cxn modelId="60" srcId="0" destId="10" srcOrd="0" destOrd="0"/>
        <dgm:cxn modelId="70" srcId="0" destId="20" srcOrd="1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20">
          <dgm:prSet phldr="1"/>
        </dgm:pt>
        <dgm:pt modelId="30">
          <dgm:prSet phldr="1"/>
        </dgm:pt>
        <dgm:pt modelId="40">
          <dgm:prSet phldr="1"/>
        </dgm:pt>
      </dgm:ptLst>
      <dgm:cxnLst>
        <dgm:cxn modelId="60" srcId="0" destId="10" srcOrd="0" destOrd="0"/>
        <dgm:cxn modelId="70" srcId="0" destId="20" srcOrd="1" destOrd="0"/>
        <dgm:cxn modelId="80" srcId="0" destId="30" srcOrd="2" destOrd="0"/>
        <dgm:cxn modelId="90" srcId="0" destId="40" srcOrd="3" destOrd="0"/>
      </dgm:cxnLst>
      <dgm:bg/>
      <dgm:whole/>
    </dgm:dataModel>
  </dgm:clrData>
  <dgm:layoutNode name="rootnode">
    <dgm:varLst>
      <dgm:chMax/>
      <dgm:chPref/>
      <dgm:dir/>
      <dgm:animLvl val="lvl"/>
    </dgm:varLst>
    <dgm:choose name="Name0">
      <dgm:if name="Name1" func="var" arg="dir" op="equ" val="norm">
        <dgm:alg type="snake">
          <dgm:param type="grDir" val="tL"/>
          <dgm:param type="flowDir" val="row"/>
          <dgm:param type="off" val="off"/>
          <dgm:param type="bkpt" val="fixed"/>
          <dgm:param type="bkPtFixedVal" val="1"/>
        </dgm:alg>
      </dgm:if>
      <dgm:else name="Name2">
        <dgm:alg type="snake">
          <dgm:param type="grDir" val="tR"/>
          <dgm:param type="flowDir" val="row"/>
          <dgm:param type="off" val="off"/>
          <dgm:param type="bkpt" val="fixed"/>
          <dgm:param type="bkPtFixedVal" val="1"/>
        </dgm:alg>
      </dgm:else>
    </dgm:choose>
    <dgm:shape xmlns:r="http://schemas.openxmlformats.org/officeDocument/2006/relationships" r:blip="">
      <dgm:adjLst/>
    </dgm:shape>
    <dgm:choose name="Name3">
      <dgm:if name="Name4" func="var" arg="dir" op="equ" val="norm">
        <dgm:constrLst>
          <dgm:constr type="alignOff" forName="rootnode" val="0.48"/>
          <dgm:constr type="primFontSz" for="des" forName="ParentText" val="65"/>
          <dgm:constr type="primFontSz" for="des" forName="ChildText" refType="primFontSz" refFor="des" refForName="ParentText" op="lte"/>
          <dgm:constr type="w" for="ch" forName="composite" refType="w"/>
          <dgm:constr type="h" for="ch" forName="composite" refType="h"/>
          <dgm:constr type="sp" refType="h" refFor="ch" refForName="composite" op="equ" fact="-0.38"/>
        </dgm:constrLst>
      </dgm:if>
      <dgm:else name="Name5">
        <dgm:constrLst>
          <dgm:constr type="alignOff" forName="rootnode" val="0.48"/>
          <dgm:constr type="primFontSz" for="des" forName="ParentText" val="65"/>
          <dgm:constr type="primFontSz" for="des" forName="ChildText" refType="primFontSz" refFor="des" refForName="ParentText" op="lte"/>
          <dgm:constr type="w" for="ch" forName="composite" refType="w"/>
          <dgm:constr type="h" for="ch" forName="composite" refType="h"/>
          <dgm:constr type="sp" refType="h" refFor="ch" refForName="composite" op="equ" fact="-0.38"/>
        </dgm:constrLst>
      </dgm:else>
    </dgm:choose>
    <dgm:forEach name="nodesForEach" axis="ch" ptType="node">
      <dgm:layoutNode name="composite">
        <dgm:alg type="composite">
          <dgm:param type="ar" val="1.2439"/>
        </dgm:alg>
        <dgm:shape xmlns:r="http://schemas.openxmlformats.org/officeDocument/2006/relationships" r:blip="">
          <dgm:adjLst/>
        </dgm:shape>
        <dgm:choose name="Name6">
          <dgm:if name="Name7" func="var" arg="dir" op="equ" val="norm">
            <dgm:constrLst>
              <dgm:constr type="l" for="ch" forName="bentUpArrow1" refType="w" fact="0.07"/>
              <dgm:constr type="t" for="ch" forName="bentUpArrow1" refType="h" fact="0.524"/>
              <dgm:constr type="w" for="ch" forName="bentUpArrow1" refType="w" fact="0.3844"/>
              <dgm:constr type="h" for="ch" forName="bentUpArrow1" refType="h" fact="0.42"/>
              <dgm:constr type="l" for="ch" forName="ParentText" refType="w" fact="0"/>
              <dgm:constr type="t" for="ch" forName="ParentText" refType="h" fact="0"/>
              <dgm:constr type="w" for="ch" forName="ParentText" refType="w" fact="0.5684"/>
              <dgm:constr type="h" for="ch" forName="ParentText" refType="h" fact="0.4949"/>
              <dgm:constr type="l" for="ch" forName="ChildText" refType="w" refFor="ch" refForName="ParentText"/>
              <dgm:constr type="t" for="ch" forName="ChildText" refType="h" fact="0.05"/>
              <dgm:constr type="w" for="ch" forName="ChildText" refType="w" fact="0.4134"/>
              <dgm:constr type="h" for="ch" forName="ChildText" refType="h" fact="0.4"/>
              <dgm:constr type="l" for="ch" forName="FinalChildText" refType="w" refFor="ch" refForName="ParentText"/>
              <dgm:constr type="t" for="ch" forName="FinalChildText" refType="h" fact="0.05"/>
              <dgm:constr type="w" for="ch" forName="FinalChildText" refType="w" fact="0.4134"/>
              <dgm:constr type="h" for="ch" forName="FinalChildText" refType="h" fact="0.4"/>
            </dgm:constrLst>
          </dgm:if>
          <dgm:else name="Name8">
            <dgm:constrLst>
              <dgm:constr type="r" for="ch" forName="bentUpArrow1" refType="w" fact="0.97"/>
              <dgm:constr type="t" for="ch" forName="bentUpArrow1" refType="h" fact="0.524"/>
              <dgm:constr type="w" for="ch" forName="bentUpArrow1" refType="w" fact="0.3844"/>
              <dgm:constr type="h" for="ch" forName="bentUpArrow1" refType="h" fact="0.42"/>
              <dgm:constr type="l" for="ch" forName="ParentText" refType="w" fact="0.4316"/>
              <dgm:constr type="t" for="ch" forName="ParentText" refType="h" fact="0"/>
              <dgm:constr type="w" for="ch" forName="ParentText" refType="w" fact="0.5684"/>
              <dgm:constr type="h" for="ch" forName="ParentText" refType="h" fact="0.4949"/>
              <dgm:constr type="l" for="ch" forName="ChildText" refType="w" fact="0"/>
              <dgm:constr type="t" for="ch" forName="ChildText" refType="h" fact="0.05"/>
              <dgm:constr type="w" for="ch" forName="ChildText" refType="w" fact="0.4134"/>
              <dgm:constr type="h" for="ch" forName="ChildText" refType="h" fact="0.4"/>
              <dgm:constr type="l" for="ch" forName="FinalChildText" refType="w" fact="0"/>
              <dgm:constr type="t" for="ch" forName="FinalChildText" refType="h" fact="0.05"/>
              <dgm:constr type="w" for="ch" forName="FinalChildText" refType="w" fact="0.4134"/>
              <dgm:constr type="h" for="ch" forName="FinalChildText" refType="h" fact="0.4"/>
            </dgm:constrLst>
          </dgm:else>
        </dgm:choose>
        <dgm:choose name="Name9">
          <dgm:if name="Name10" axis="followSib" ptType="node" func="cnt" op="gte" val="1">
            <dgm:layoutNode name="bentUpArrow1" styleLbl="alignImgPlace1">
              <dgm:alg type="sp"/>
              <dgm:choose name="Name11">
                <dgm:if name="Name12" func="var" arg="dir" op="equ" val="norm">
                  <dgm:shape xmlns:r="http://schemas.openxmlformats.org/officeDocument/2006/relationships" rot="90" type="bentUpArrow" r:blip="">
                    <dgm:adjLst>
                      <dgm:adj idx="1" val="0.3284"/>
                      <dgm:adj idx="2" val="0.25"/>
                      <dgm:adj idx="3" val="0.3578"/>
                    </dgm:adjLst>
                  </dgm:shape>
                </dgm:if>
                <dgm:else name="Name13">
                  <dgm:shape xmlns:r="http://schemas.openxmlformats.org/officeDocument/2006/relationships" rot="180" type="bentArrow" r:blip="">
                    <dgm:adjLst>
                      <dgm:adj idx="1" val="0.3284"/>
                      <dgm:adj idx="2" val="0.25"/>
                      <dgm:adj idx="3" val="0.3578"/>
                      <dgm:adj idx="4" val="0"/>
                    </dgm:adjLst>
                  </dgm:shape>
                </dgm:else>
              </dgm:choose>
              <dgm:presOf/>
            </dgm:layoutNode>
          </dgm:if>
          <dgm:else name="Name14"/>
        </dgm:choose>
        <dgm:layoutNode name="ParentText" styleLbl="node1">
          <dgm:varLst>
            <dgm:chMax val="1"/>
            <dgm:chPref val="1"/>
            <dgm:bulletEnabled val="1"/>
          </dgm:varLst>
          <dgm:alg type="tx"/>
          <dgm:shape xmlns:r="http://schemas.openxmlformats.org/officeDocument/2006/relationships" type="roundRect" r:blip="">
            <dgm:adjLst>
              <dgm:adj idx="1" val="0.1667"/>
            </dgm:adjLst>
          </dgm:shape>
          <dgm:presOf axis="self" ptType="node"/>
          <dgm:constrLst>
            <dgm:constr type="lMarg" refType="primFontSz" fact="0.3"/>
            <dgm:constr type="rMarg" refType="primFontSz" fact="0.3"/>
            <dgm:constr type="tMarg" refType="primFontSz" fact="0.3"/>
            <dgm:constr type="bMarg" refType="primFontSz" fact="0.3"/>
          </dgm:constrLst>
          <dgm:ruleLst>
            <dgm:rule type="primFontSz" val="5" fact="NaN" max="NaN"/>
          </dgm:ruleLst>
        </dgm:layoutNode>
        <dgm:choose name="Name15">
          <dgm:if name="Name16" axis="followSib" ptType="node" func="cnt" op="equ" val="0">
            <dgm:choose name="Name17">
              <dgm:if name="Name18" axis="ch" ptType="node" func="cnt" op="gte" val="1">
                <dgm:layoutNode name="FinalChildText" styleLbl="revTx">
                  <dgm:varLst>
                    <dgm:chMax val="0"/>
                    <dgm:chPref val="0"/>
                    <dgm:bulletEnabled val="1"/>
                  </dgm:varLst>
                  <dgm:alg type="tx">
                    <dgm:param type="stBulletLvl" val="1"/>
                    <dgm:param type="txAnchorVertCh" val="mid"/>
                    <dgm:param type="parTxLTRAlign" val="l"/>
                  </dgm:alg>
                  <dgm:shape xmlns:r="http://schemas.openxmlformats.org/officeDocument/2006/relationships" type="rect" r:blip="">
                    <dgm:adjLst/>
                  </dgm:shape>
                  <dgm:presOf axis="des" ptType="node"/>
                  <dgm:constrLst>
                    <dgm:constr type="lMarg" refType="primFontSz" fact="0.3"/>
                    <dgm:constr type="rMarg" refType="primFontSz" fact="0.3"/>
                    <dgm:constr type="tMarg" refType="primFontSz" fact="0.3"/>
                    <dgm:constr type="bMarg" refType="primFontSz" fact="0.3"/>
                  </dgm:constrLst>
                  <dgm:ruleLst>
                    <dgm:rule type="primFontSz" val="5" fact="NaN" max="NaN"/>
                  </dgm:ruleLst>
                </dgm:layoutNode>
              </dgm:if>
              <dgm:else name="Name19"/>
            </dgm:choose>
          </dgm:if>
          <dgm:else name="Name20">
            <dgm:layoutNode name="ChildText" styleLbl="revTx">
              <dgm:varLst>
                <dgm:chMax val="0"/>
                <dgm:chPref val="0"/>
                <dgm:bulletEnabled val="1"/>
              </dgm:varLst>
              <dgm:alg type="tx">
                <dgm:param type="stBulletLvl" val="1"/>
                <dgm:param type="txAnchorVertCh" val="mid"/>
                <dgm:param type="parTxLTRAlign" val="l"/>
              </dgm:alg>
              <dgm:shape xmlns:r="http://schemas.openxmlformats.org/officeDocument/2006/relationships" type="rect" r:blip="">
                <dgm:adjLst/>
              </dgm:shape>
              <dgm:presOf axis="des" ptType="node"/>
              <dgm:constrLst>
                <dgm:constr type="lMarg" refType="primFontSz" fact="0.3"/>
                <dgm:constr type="rMarg" refType="primFontSz" fact="0.3"/>
                <dgm:constr type="tMarg" refType="primFontSz" fact="0.3"/>
                <dgm:constr type="bMarg" refType="primFontSz" fact="0.3"/>
              </dgm:constrLst>
              <dgm:ruleLst>
                <dgm:rule type="primFontSz" val="5" fact="NaN" max="NaN"/>
              </dgm:ruleLst>
            </dgm:layoutNode>
          </dgm:else>
        </dgm:choos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7BDB0-CD20-48FC-B579-1F0F5D856BDD}" type="datetimeFigureOut">
              <a:rPr lang="en-GB" smtClean="0"/>
              <a:t>20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F7FE3-3CF7-47E2-8B71-091075F21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1763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7BDB0-CD20-48FC-B579-1F0F5D856BDD}" type="datetimeFigureOut">
              <a:rPr lang="en-GB" smtClean="0"/>
              <a:t>20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F7FE3-3CF7-47E2-8B71-091075F21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5985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7BDB0-CD20-48FC-B579-1F0F5D856BDD}" type="datetimeFigureOut">
              <a:rPr lang="en-GB" smtClean="0"/>
              <a:t>20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F7FE3-3CF7-47E2-8B71-091075F21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2047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7BDB0-CD20-48FC-B579-1F0F5D856BDD}" type="datetimeFigureOut">
              <a:rPr lang="en-GB" smtClean="0"/>
              <a:t>20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F7FE3-3CF7-47E2-8B71-091075F21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3912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7BDB0-CD20-48FC-B579-1F0F5D856BDD}" type="datetimeFigureOut">
              <a:rPr lang="en-GB" smtClean="0"/>
              <a:t>20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F7FE3-3CF7-47E2-8B71-091075F21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9796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7BDB0-CD20-48FC-B579-1F0F5D856BDD}" type="datetimeFigureOut">
              <a:rPr lang="en-GB" smtClean="0"/>
              <a:t>20/10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F7FE3-3CF7-47E2-8B71-091075F21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8026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7BDB0-CD20-48FC-B579-1F0F5D856BDD}" type="datetimeFigureOut">
              <a:rPr lang="en-GB" smtClean="0"/>
              <a:t>20/10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F7FE3-3CF7-47E2-8B71-091075F21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8873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7BDB0-CD20-48FC-B579-1F0F5D856BDD}" type="datetimeFigureOut">
              <a:rPr lang="en-GB" smtClean="0"/>
              <a:t>20/10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F7FE3-3CF7-47E2-8B71-091075F21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1779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7BDB0-CD20-48FC-B579-1F0F5D856BDD}" type="datetimeFigureOut">
              <a:rPr lang="en-GB" smtClean="0"/>
              <a:t>20/10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F7FE3-3CF7-47E2-8B71-091075F21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2453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7BDB0-CD20-48FC-B579-1F0F5D856BDD}" type="datetimeFigureOut">
              <a:rPr lang="en-GB" smtClean="0"/>
              <a:t>20/10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F7FE3-3CF7-47E2-8B71-091075F21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8257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D7BDB0-CD20-48FC-B579-1F0F5D856BDD}" type="datetimeFigureOut">
              <a:rPr lang="en-GB" smtClean="0"/>
              <a:t>20/10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7F7FE3-3CF7-47E2-8B71-091075F21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7159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D7BDB0-CD20-48FC-B579-1F0F5D856BDD}" type="datetimeFigureOut">
              <a:rPr lang="en-GB" smtClean="0"/>
              <a:t>20/10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F7FE3-3CF7-47E2-8B71-091075F21EE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7440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/>
          <p:cNvGraphicFramePr/>
          <p:nvPr>
            <p:extLst>
              <p:ext uri="{D42A27DB-BD31-4B8C-83A1-F6EECF244321}">
                <p14:modId xmlns:p14="http://schemas.microsoft.com/office/powerpoint/2010/main" val="770970517"/>
              </p:ext>
            </p:extLst>
          </p:nvPr>
        </p:nvGraphicFramePr>
        <p:xfrm>
          <a:off x="1524000" y="1397000"/>
          <a:ext cx="6096000" cy="4064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2339752" y="2924944"/>
            <a:ext cx="10081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-21 lost to follow-up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501981" y="2276872"/>
            <a:ext cx="10801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-7 congenital</a:t>
            </a:r>
          </a:p>
          <a:p>
            <a:r>
              <a:rPr lang="en-GB" sz="1200" dirty="0" smtClean="0"/>
              <a:t> abnormalitie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784533" y="3537069"/>
            <a:ext cx="11266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-140 non white mothers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563888" y="4293096"/>
            <a:ext cx="11521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-1000 no cord blood</a:t>
            </a:r>
            <a:endParaRPr lang="en-GB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4283968" y="4941168"/>
            <a:ext cx="12601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-</a:t>
            </a:r>
            <a:r>
              <a:rPr lang="en-GB" sz="1200" dirty="0"/>
              <a:t>8</a:t>
            </a:r>
            <a:r>
              <a:rPr lang="en-GB" sz="1200" dirty="0" smtClean="0"/>
              <a:t> </a:t>
            </a:r>
            <a:r>
              <a:rPr lang="en-GB" sz="1200" dirty="0"/>
              <a:t>genotyping failures</a:t>
            </a:r>
          </a:p>
        </p:txBody>
      </p:sp>
    </p:spTree>
    <p:extLst>
      <p:ext uri="{BB962C8B-B14F-4D97-AF65-F5344CB8AC3E}">
        <p14:creationId xmlns:p14="http://schemas.microsoft.com/office/powerpoint/2010/main" val="12599780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</TotalTime>
  <Words>30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ila</dc:creator>
  <cp:lastModifiedBy>Sheila Barton</cp:lastModifiedBy>
  <cp:revision>20</cp:revision>
  <dcterms:created xsi:type="dcterms:W3CDTF">2015-10-08T13:53:45Z</dcterms:created>
  <dcterms:modified xsi:type="dcterms:W3CDTF">2015-10-20T09:29:58Z</dcterms:modified>
</cp:coreProperties>
</file>